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-102" y="-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619698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0700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29095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61641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2620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64771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67500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23251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80432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875252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77150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2DE02-85E4-4D33-BF36-1C3E18583729}" type="datetimeFigureOut">
              <a:rPr lang="ko-KR" altLang="en-US" smtClean="0"/>
              <a:pPr/>
              <a:t>2024-05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4093A-EB7B-405E-8471-6786BF87436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339303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07710" y="38280"/>
            <a:ext cx="4097542" cy="3333593"/>
          </a:xfr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885519" y="44335"/>
            <a:ext cx="4127183" cy="3346769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67696" y="3401556"/>
            <a:ext cx="4037556" cy="3296362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921574" y="3391104"/>
            <a:ext cx="4091128" cy="3354526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161931" y="4698484"/>
            <a:ext cx="3149118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Supplementary figure 5. ROC curve in non-obese subgroup </a:t>
            </a:r>
          </a:p>
          <a:p>
            <a:endParaRPr lang="en-US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2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4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6 year follow up</a:t>
            </a:r>
          </a:p>
          <a:p>
            <a:pPr marL="342900" indent="-342900">
              <a:buAutoNum type="alphaLcParenR"/>
            </a:pP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8 year follow up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5859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a)</a:t>
            </a:r>
            <a:endParaRPr lang="ko-KR" alt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4689516" y="44335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b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251374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c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4689515" y="3274049"/>
            <a:ext cx="523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d</a:t>
            </a:r>
            <a:r>
              <a:rPr lang="en-US" altLang="ko-KR" sz="1400" dirty="0" smtClean="0"/>
              <a:t>)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xmlns="" val="1119035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33</Words>
  <Application>Microsoft Office PowerPoint</Application>
  <PresentationFormat>사용자 지정</PresentationFormat>
  <Paragraphs>1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박성근</cp:lastModifiedBy>
  <cp:revision>18</cp:revision>
  <dcterms:created xsi:type="dcterms:W3CDTF">2024-01-24T23:55:32Z</dcterms:created>
  <dcterms:modified xsi:type="dcterms:W3CDTF">2024-05-04T11:12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</Properties>
</file>